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844" r:id="rId2"/>
  </p:sldIdLst>
  <p:sldSz cx="9144000" cy="6858000" type="screen4x3"/>
  <p:notesSz cx="6742113" cy="9872663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8F8"/>
    <a:srgbClr val="E9ED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3" autoAdjust="0"/>
    <p:restoredTop sz="96586" autoAdjust="0"/>
  </p:normalViewPr>
  <p:slideViewPr>
    <p:cSldViewPr>
      <p:cViewPr>
        <p:scale>
          <a:sx n="100" d="100"/>
          <a:sy n="100" d="100"/>
        </p:scale>
        <p:origin x="1638" y="32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00" d="100"/>
        <a:sy n="3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E28B11F-B067-4D5F-9990-AB91A4C8C3B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2588" cy="493713"/>
          </a:xfrm>
          <a:prstGeom prst="rect">
            <a:avLst/>
          </a:prstGeom>
        </p:spPr>
        <p:txBody>
          <a:bodyPr vert="horz" lIns="90946" tIns="45473" rIns="90946" bIns="45473" rtlCol="0"/>
          <a:lstStyle>
            <a:lvl1pPr algn="l" eaLnBrk="1" latinLnBrk="1" hangingPunct="1">
              <a:defRPr sz="1200">
                <a:latin typeface="맑은 고딕" panose="020B0503020000020004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7032FC-8672-4B0D-A359-3EC0D0BB7B83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7938" y="0"/>
            <a:ext cx="2922587" cy="493713"/>
          </a:xfrm>
          <a:prstGeom prst="rect">
            <a:avLst/>
          </a:prstGeom>
        </p:spPr>
        <p:txBody>
          <a:bodyPr vert="horz" wrap="square" lIns="90946" tIns="45473" rIns="90946" bIns="45473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pPr>
              <a:defRPr/>
            </a:pPr>
            <a:fld id="{F9E94357-D643-4258-ABA8-7B7F2D7C0495}" type="datetimeFigureOut">
              <a:rPr lang="ko-KR" altLang="en-US"/>
              <a:pPr>
                <a:defRPr/>
              </a:pPr>
              <a:t>2022-01-20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FCED51-5C2F-40A5-ADB9-A32619C12B5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7363"/>
            <a:ext cx="2922588" cy="493712"/>
          </a:xfrm>
          <a:prstGeom prst="rect">
            <a:avLst/>
          </a:prstGeom>
        </p:spPr>
        <p:txBody>
          <a:bodyPr vert="horz" lIns="90946" tIns="45473" rIns="90946" bIns="45473" rtlCol="0" anchor="b"/>
          <a:lstStyle>
            <a:lvl1pPr algn="l" eaLnBrk="1" latinLnBrk="1" hangingPunct="1">
              <a:defRPr sz="1200">
                <a:latin typeface="맑은 고딕" panose="020B0503020000020004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5969B3-6A90-4B81-96E7-8727891F063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7938" y="9377363"/>
            <a:ext cx="2922587" cy="493712"/>
          </a:xfrm>
          <a:prstGeom prst="rect">
            <a:avLst/>
          </a:prstGeom>
        </p:spPr>
        <p:txBody>
          <a:bodyPr vert="horz" wrap="square" lIns="90946" tIns="45473" rIns="90946" bIns="45473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fld id="{DCDD71EB-2CF5-4522-89D3-381F75D65D7A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D1D8F7CA-18FA-44BC-B6CD-120C9E41FF7C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2588" cy="493713"/>
          </a:xfrm>
          <a:prstGeom prst="rect">
            <a:avLst/>
          </a:prstGeom>
        </p:spPr>
        <p:txBody>
          <a:bodyPr vert="horz" wrap="square" lIns="90946" tIns="45473" rIns="90946" bIns="45473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kumimoji="0" sz="1200"/>
            </a:lvl1pPr>
          </a:lstStyle>
          <a:p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B9C08C0-C4F6-403A-82EA-83C51C0616A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17938" y="0"/>
            <a:ext cx="2922587" cy="493713"/>
          </a:xfrm>
          <a:prstGeom prst="rect">
            <a:avLst/>
          </a:prstGeom>
        </p:spPr>
        <p:txBody>
          <a:bodyPr vert="horz" wrap="square" lIns="90946" tIns="45473" rIns="90946" bIns="45473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/>
            </a:lvl1pPr>
          </a:lstStyle>
          <a:p>
            <a:fld id="{CD35584C-1295-4D2F-B4DF-59EAB61280ED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4" name="슬라이드 이미지 개체 틀 3">
            <a:extLst>
              <a:ext uri="{FF2B5EF4-FFF2-40B4-BE49-F238E27FC236}">
                <a16:creationId xmlns:a16="http://schemas.microsoft.com/office/drawing/2014/main" id="{F415C572-1D51-4191-AA70-8618FCDE39CB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903288" y="741363"/>
            <a:ext cx="4935537" cy="37004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946" tIns="45473" rIns="90946" bIns="45473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>
            <a:extLst>
              <a:ext uri="{FF2B5EF4-FFF2-40B4-BE49-F238E27FC236}">
                <a16:creationId xmlns:a16="http://schemas.microsoft.com/office/drawing/2014/main" id="{7CD5015F-7758-4F57-99C2-2F0F5C2420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4688" y="4689475"/>
            <a:ext cx="5392737" cy="4441825"/>
          </a:xfrm>
          <a:prstGeom prst="rect">
            <a:avLst/>
          </a:prstGeom>
        </p:spPr>
        <p:txBody>
          <a:bodyPr vert="horz" wrap="square" lIns="90946" tIns="45473" rIns="90946" bIns="4547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5FD5B4-A3DE-419A-929F-E99632B1F4FA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22588" cy="493712"/>
          </a:xfrm>
          <a:prstGeom prst="rect">
            <a:avLst/>
          </a:prstGeom>
        </p:spPr>
        <p:txBody>
          <a:bodyPr vert="horz" wrap="square" lIns="90946" tIns="45473" rIns="90946" bIns="45473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kumimoji="0"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E663627-AE87-4151-A2EA-66420197F02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17938" y="9377363"/>
            <a:ext cx="2922587" cy="493712"/>
          </a:xfrm>
          <a:prstGeom prst="rect">
            <a:avLst/>
          </a:prstGeom>
        </p:spPr>
        <p:txBody>
          <a:bodyPr vert="horz" wrap="square" lIns="90946" tIns="45473" rIns="90946" bIns="45473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/>
            </a:lvl1pPr>
          </a:lstStyle>
          <a:p>
            <a:fld id="{C95A9FCE-0834-4762-ACAF-1550353017A1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anose="020B0503020000020004" pitchFamily="50" charset="-127"/>
        <a:ea typeface="맑은 고딕" panose="020B0503020000020004" pitchFamily="50" charset="-127"/>
        <a:cs typeface="맑은 고딕" panose="020B0503020000020004" pitchFamily="50" charset="-127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anose="020B0503020000020004" pitchFamily="50" charset="-127"/>
        <a:ea typeface="맑은 고딕" panose="020B0503020000020004" pitchFamily="50" charset="-127"/>
        <a:cs typeface="맑은 고딕" panose="020B0503020000020004" pitchFamily="50" charset="-127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anose="020B0503020000020004" pitchFamily="50" charset="-127"/>
        <a:ea typeface="맑은 고딕" panose="020B0503020000020004" pitchFamily="50" charset="-127"/>
        <a:cs typeface="맑은 고딕" panose="020B0503020000020004" pitchFamily="50" charset="-127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anose="020B0503020000020004" pitchFamily="50" charset="-127"/>
        <a:ea typeface="맑은 고딕" panose="020B0503020000020004" pitchFamily="50" charset="-127"/>
        <a:cs typeface="맑은 고딕" panose="020B0503020000020004" pitchFamily="50" charset="-127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anose="020B0503020000020004" pitchFamily="50" charset="-127"/>
        <a:ea typeface="맑은 고딕" panose="020B0503020000020004" pitchFamily="50" charset="-127"/>
        <a:cs typeface="맑은 고딕" panose="020B0503020000020004" pitchFamily="50" charset="-127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>
            <a:extLst>
              <a:ext uri="{FF2B5EF4-FFF2-40B4-BE49-F238E27FC236}">
                <a16:creationId xmlns:a16="http://schemas.microsoft.com/office/drawing/2014/main" id="{AFA956F6-E135-48A5-9A0D-1AF8C2D3B86A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>
            <a:extLst>
              <a:ext uri="{FF2B5EF4-FFF2-40B4-BE49-F238E27FC236}">
                <a16:creationId xmlns:a16="http://schemas.microsoft.com/office/drawing/2014/main" id="{92E0F449-4950-478D-B7E8-B163FA08BA48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ko-KR" altLang="en-US">
              <a:ea typeface="굴림" panose="020B0600000101010101" pitchFamily="50" charset="-127"/>
            </a:endParaRPr>
          </a:p>
        </p:txBody>
      </p:sp>
      <p:sp>
        <p:nvSpPr>
          <p:cNvPr id="5124" name="Slide Number Placeholder 3">
            <a:extLst>
              <a:ext uri="{FF2B5EF4-FFF2-40B4-BE49-F238E27FC236}">
                <a16:creationId xmlns:a16="http://schemas.microsoft.com/office/drawing/2014/main" id="{36F34404-252D-4DEF-8AC9-A556C388D91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9pPr>
          </a:lstStyle>
          <a:p>
            <a:fld id="{A8DC40FF-58B6-4FC2-8642-C9E6613AEB63}" type="slidenum">
              <a:rPr kumimoji="0" lang="ko-KR" altLang="en-US"/>
              <a:pPr/>
              <a:t>1</a:t>
            </a:fld>
            <a:endParaRPr kumimoji="0"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30D10C-6295-4200-8EC1-0F36D64C0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6B137DD-3180-49C7-B218-8F613F34C33C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CF8589-86B9-47C2-8916-A8C575286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4F58172-568C-4CD5-A3FE-7F9A236FE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AD8952-0DDD-45C9-836D-E7A1E9EE529D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8821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3ED7006-5499-40D0-8AEA-2E78A0DC9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464CF9F-1C00-4D71-BF5E-55C3D9E18E7B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EBDC46-0216-462E-886F-F8D04DD7F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3B29F28-767C-4055-9155-0722E5AB2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066C0E2-2599-4F90-B18B-CCD43031F85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072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41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41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4F3BE1-D6D5-4D82-A3DE-7350BA155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7EAFA-3E6F-4364-8102-A424101058DB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B58828A-D67D-4D88-99B6-A0454D812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D0CCE2B-4DD8-49E9-9347-7B726C1EA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D0F6894-7D7D-4A5A-B295-E9B8305F5BB6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7513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36C9349-17E1-4AF3-9E32-90C29F860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D0B8AD5-DEDC-4336-AD15-39DF1BA6F5D2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FF8A0A6-CEF1-4436-B9F5-82F68C71F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ED4670-00E4-47D2-A212-D66989C38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D3E91C-656B-4BCD-91E4-1AF5CF669F22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2452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3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9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05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E8DB8B0-5A18-42F9-B23D-6F4A262AE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588F025-EEC8-4AB9-835F-E972134CB220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F61078-18F9-4FE9-A27C-370C6F081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359559-FC26-47C0-9EA7-8D2E02DCD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25A2E2-5AB5-4DF3-9F95-E73048623D63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331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3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1"/>
            </a:lvl4pPr>
            <a:lvl5pPr>
              <a:defRPr sz="1351"/>
            </a:lvl5pPr>
            <a:lvl6pPr>
              <a:defRPr sz="1351"/>
            </a:lvl6pPr>
            <a:lvl7pPr>
              <a:defRPr sz="1351"/>
            </a:lvl7pPr>
            <a:lvl8pPr>
              <a:defRPr sz="1351"/>
            </a:lvl8pPr>
            <a:lvl9pPr>
              <a:defRPr sz="13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3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1"/>
            </a:lvl4pPr>
            <a:lvl5pPr>
              <a:defRPr sz="1351"/>
            </a:lvl5pPr>
            <a:lvl6pPr>
              <a:defRPr sz="1351"/>
            </a:lvl6pPr>
            <a:lvl7pPr>
              <a:defRPr sz="1351"/>
            </a:lvl7pPr>
            <a:lvl8pPr>
              <a:defRPr sz="1351"/>
            </a:lvl8pPr>
            <a:lvl9pPr>
              <a:defRPr sz="13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1CABDA15-91D5-4A6A-B399-64653D396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A52CC0B-8D82-4ACE-A417-10DD4CDEB8BE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A52E17D1-672B-4B00-B1B8-3DEBD81FD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19047462-E3F8-4E68-B2D7-DA3095F6F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A74D95-DA85-4B93-BAEC-5C07A3D569DE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5022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1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1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>
            <a:extLst>
              <a:ext uri="{FF2B5EF4-FFF2-40B4-BE49-F238E27FC236}">
                <a16:creationId xmlns:a16="http://schemas.microsoft.com/office/drawing/2014/main" id="{F86AAF4C-23EF-48D1-A672-907B92F58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4BBC64A-F721-465A-91FD-B8B9C05DD982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8" name="바닥글 개체 틀 4">
            <a:extLst>
              <a:ext uri="{FF2B5EF4-FFF2-40B4-BE49-F238E27FC236}">
                <a16:creationId xmlns:a16="http://schemas.microsoft.com/office/drawing/2014/main" id="{C028AF9C-C436-46AE-83A4-F7962D173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9" name="슬라이드 번호 개체 틀 5">
            <a:extLst>
              <a:ext uri="{FF2B5EF4-FFF2-40B4-BE49-F238E27FC236}">
                <a16:creationId xmlns:a16="http://schemas.microsoft.com/office/drawing/2014/main" id="{998FE550-686E-4AD6-BB95-FDB56FB0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C48130-E5F3-4F8C-B682-13F204FB881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0128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>
            <a:extLst>
              <a:ext uri="{FF2B5EF4-FFF2-40B4-BE49-F238E27FC236}">
                <a16:creationId xmlns:a16="http://schemas.microsoft.com/office/drawing/2014/main" id="{CEF22CA4-0E3D-460D-A53F-37EE4DBDA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6156C05-FB15-48AF-87D5-ABD20009BAE2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4" name="바닥글 개체 틀 4">
            <a:extLst>
              <a:ext uri="{FF2B5EF4-FFF2-40B4-BE49-F238E27FC236}">
                <a16:creationId xmlns:a16="http://schemas.microsoft.com/office/drawing/2014/main" id="{55BBEBA3-B8B9-4138-B188-DC9F2EB69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5" name="슬라이드 번호 개체 틀 5">
            <a:extLst>
              <a:ext uri="{FF2B5EF4-FFF2-40B4-BE49-F238E27FC236}">
                <a16:creationId xmlns:a16="http://schemas.microsoft.com/office/drawing/2014/main" id="{9D943017-CDCB-469F-82AD-CD6E7C35C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2297C0-0EE5-4C8E-997F-5EBA73BB419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5250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>
            <a:extLst>
              <a:ext uri="{FF2B5EF4-FFF2-40B4-BE49-F238E27FC236}">
                <a16:creationId xmlns:a16="http://schemas.microsoft.com/office/drawing/2014/main" id="{27D378DB-5D3B-4EDD-9559-9FB356703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23B87FF-7B42-4281-A0D6-F5522424A13F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3" name="바닥글 개체 틀 4">
            <a:extLst>
              <a:ext uri="{FF2B5EF4-FFF2-40B4-BE49-F238E27FC236}">
                <a16:creationId xmlns:a16="http://schemas.microsoft.com/office/drawing/2014/main" id="{615E52A2-D30A-4E01-919F-D55D257F2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4" name="슬라이드 번호 개체 틀 5">
            <a:extLst>
              <a:ext uri="{FF2B5EF4-FFF2-40B4-BE49-F238E27FC236}">
                <a16:creationId xmlns:a16="http://schemas.microsoft.com/office/drawing/2014/main" id="{A2543E2E-DBD3-4477-8A3A-1D5E3601B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C674F6A-6ED5-4E03-AC3B-9FDF9C9AADC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9710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3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051"/>
            </a:lvl1pPr>
            <a:lvl2pPr marL="342891" indent="0">
              <a:buNone/>
              <a:defRPr sz="900"/>
            </a:lvl2pPr>
            <a:lvl3pPr marL="685783" indent="0">
              <a:buNone/>
              <a:defRPr sz="751"/>
            </a:lvl3pPr>
            <a:lvl4pPr marL="1028674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1" indent="0">
              <a:buNone/>
              <a:defRPr sz="67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BE272B6D-8A7C-4D09-A5ED-BF73597CC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BBE317-7192-4FAD-88D8-AE02854F7DFE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5798246A-6F73-4D6C-B843-62B75D634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6B3349BA-C714-4698-9C25-A318B5EAC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80B2052-73FE-4478-92A2-1006779FF50E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4851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1"/>
            </a:lvl1pPr>
            <a:lvl2pPr marL="342891" indent="0">
              <a:buNone/>
              <a:defRPr sz="900"/>
            </a:lvl2pPr>
            <a:lvl3pPr marL="685783" indent="0">
              <a:buNone/>
              <a:defRPr sz="751"/>
            </a:lvl3pPr>
            <a:lvl4pPr marL="1028674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1" indent="0">
              <a:buNone/>
              <a:defRPr sz="67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252E9ED9-DAAA-476E-9009-D57C4D05C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B729EF9-3F41-4F15-9C3A-C78F59F71898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B7D3A27B-EFF4-4F09-8CD4-1A53753CE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48D45D5A-BEA0-4883-AE65-D0FD50AD7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EABBDDE-5BAB-4160-AEC1-99D3732F2CF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7727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>
            <a:extLst>
              <a:ext uri="{FF2B5EF4-FFF2-40B4-BE49-F238E27FC236}">
                <a16:creationId xmlns:a16="http://schemas.microsoft.com/office/drawing/2014/main" id="{05DCC7F7-03E1-4D3F-8120-941592D6D00E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텍스트 개체 틀 2">
            <a:extLst>
              <a:ext uri="{FF2B5EF4-FFF2-40B4-BE49-F238E27FC236}">
                <a16:creationId xmlns:a16="http://schemas.microsoft.com/office/drawing/2014/main" id="{9C690156-1B34-4CE8-A49B-E8BE837E0DC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76A1B8A-6BF8-46A1-9103-5001D4CBD6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latinLnBrk="1" hangingPunct="1">
              <a:defRPr kumimoji="0" sz="900">
                <a:solidFill>
                  <a:srgbClr val="898989"/>
                </a:solidFill>
              </a:defRPr>
            </a:lvl1pPr>
          </a:lstStyle>
          <a:p>
            <a:fld id="{1E12D0DC-9887-433B-990F-6A0B50C5C56B}" type="datetimeFigureOut">
              <a:rPr lang="ko-KR" altLang="en-US"/>
              <a:pPr/>
              <a:t>2022-01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EEE8F-3EC3-4B99-BB41-7E340044B7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latinLnBrk="1" hangingPunct="1">
              <a:defRPr kumimoji="0" sz="900">
                <a:solidFill>
                  <a:srgbClr val="898989"/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159D9C-C0F8-41C2-9125-33A6F89723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900">
                <a:solidFill>
                  <a:srgbClr val="898989"/>
                </a:solidFill>
              </a:defRPr>
            </a:lvl1pPr>
          </a:lstStyle>
          <a:p>
            <a:fld id="{9A721885-8377-49EB-AEDF-852092136B82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5pPr>
      <a:lvl6pPr marL="342891" algn="ctr" rtl="0" fontAlgn="base" latinLnBrk="1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685783" algn="ctr" rtl="0" fontAlgn="base" latinLnBrk="1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028674" algn="ctr" rtl="0" fontAlgn="base" latinLnBrk="1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371566" algn="ctr" rtl="0" fontAlgn="base" latinLnBrk="1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255588" indent="-255588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1pPr>
      <a:lvl2pPr marL="555625" indent="-212725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2pPr>
      <a:lvl3pPr marL="855663" indent="-169863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3pPr>
      <a:lvl4pPr marL="1198563" indent="-169863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4pPr>
      <a:lvl5pPr marL="1541463" indent="-169863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맑은 고딕" panose="020B0503020000020004" pitchFamily="50" charset="-127"/>
          <a:ea typeface="맑은 고딕" panose="020B0503020000020004" pitchFamily="50" charset="-127"/>
          <a:cs typeface="맑은 고딕" panose="020B0503020000020004" pitchFamily="50" charset="-127"/>
        </a:defRPr>
      </a:lvl5pPr>
      <a:lvl6pPr marL="1885904" indent="-171446" algn="l" defTabSz="685783" rtl="0" eaLnBrk="1" latinLnBrk="1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1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1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1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hyperlink" Target="http://www.ncbi.nlm.nih.gov/geo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>
            <a:extLst>
              <a:ext uri="{FF2B5EF4-FFF2-40B4-BE49-F238E27FC236}">
                <a16:creationId xmlns:a16="http://schemas.microsoft.com/office/drawing/2014/main" id="{8946D708-092F-40F8-A5F1-8CC0A8BB3A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434" y="2924225"/>
            <a:ext cx="3369394" cy="2549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>
            <a:extLst>
              <a:ext uri="{FF2B5EF4-FFF2-40B4-BE49-F238E27FC236}">
                <a16:creationId xmlns:a16="http://schemas.microsoft.com/office/drawing/2014/main" id="{EA452507-1AC6-421B-83E5-9E886BEF66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5866" y="2924225"/>
            <a:ext cx="3368023" cy="2549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>
            <a:extLst>
              <a:ext uri="{FF2B5EF4-FFF2-40B4-BE49-F238E27FC236}">
                <a16:creationId xmlns:a16="http://schemas.microsoft.com/office/drawing/2014/main" id="{0E437790-FD77-413B-B859-9D93F2B68E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48" y="260648"/>
            <a:ext cx="3368023" cy="25260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>
            <a:extLst>
              <a:ext uri="{FF2B5EF4-FFF2-40B4-BE49-F238E27FC236}">
                <a16:creationId xmlns:a16="http://schemas.microsoft.com/office/drawing/2014/main" id="{F342EE31-90F7-4A0F-9AD3-58CA1D3998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260648"/>
            <a:ext cx="3369394" cy="25260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523280E-6263-4D16-9EF9-F64F78B0A938}"/>
              </a:ext>
            </a:extLst>
          </p:cNvPr>
          <p:cNvSpPr txBox="1"/>
          <p:nvPr/>
        </p:nvSpPr>
        <p:spPr>
          <a:xfrm>
            <a:off x="107950" y="5468732"/>
            <a:ext cx="8856538" cy="11449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 Tissue distribution of RBP1 and RBP4 expression.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Expression levels of mouse and human RBP1 and RBP4 in various tissues were presented and analyzed based on microarray (GEO dataset) and RNA-seq dataset (Human Protein Atlas) in the National Center for Biotechnology Information (NCBI) archives (</a:t>
            </a:r>
            <a:r>
              <a:rPr lang="en-US" altLang="ko-KR" sz="18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  <a:hlinkClick r:id="rId7"/>
              </a:rPr>
              <a:t>www.ncbi.nlm.nih.gov/geo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</a:t>
            </a:r>
            <a:endParaRPr lang="ko-KR" altLang="ko-KR" sz="18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550</TotalTime>
  <Words>67</Words>
  <Application>Microsoft Office PowerPoint</Application>
  <PresentationFormat>화면 슬라이드 쇼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굴림</vt:lpstr>
      <vt:lpstr>Arial</vt:lpstr>
      <vt:lpstr>Calibri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ongHwan</dc:creator>
  <cp:lastModifiedBy>Kim, Dong Hwan</cp:lastModifiedBy>
  <cp:revision>3011</cp:revision>
  <cp:lastPrinted>2017-10-02T05:54:33Z</cp:lastPrinted>
  <dcterms:created xsi:type="dcterms:W3CDTF">2014-02-26T08:26:06Z</dcterms:created>
  <dcterms:modified xsi:type="dcterms:W3CDTF">2022-01-21T01:50:29Z</dcterms:modified>
</cp:coreProperties>
</file>